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84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>
        <p:scale>
          <a:sx n="45" d="100"/>
          <a:sy n="45" d="100"/>
        </p:scale>
        <p:origin x="-2424" y="-72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4D0773-A954-4ECB-8D69-B46948729227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C826A1-0E54-4645-9868-FD5C8A5C18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490391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4D0773-A954-4ECB-8D69-B46948729227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C826A1-0E54-4645-9868-FD5C8A5C18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786950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4D0773-A954-4ECB-8D69-B46948729227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C826A1-0E54-4645-9868-FD5C8A5C18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45773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4D0773-A954-4ECB-8D69-B46948729227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C826A1-0E54-4645-9868-FD5C8A5C18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88109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4D0773-A954-4ECB-8D69-B46948729227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C826A1-0E54-4645-9868-FD5C8A5C18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533170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4D0773-A954-4ECB-8D69-B46948729227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C826A1-0E54-4645-9868-FD5C8A5C18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97259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4D0773-A954-4ECB-8D69-B46948729227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C826A1-0E54-4645-9868-FD5C8A5C18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861842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4D0773-A954-4ECB-8D69-B46948729227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C826A1-0E54-4645-9868-FD5C8A5C18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328922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4D0773-A954-4ECB-8D69-B46948729227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C826A1-0E54-4645-9868-FD5C8A5C18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46634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4D0773-A954-4ECB-8D69-B46948729227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C826A1-0E54-4645-9868-FD5C8A5C18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386338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4D0773-A954-4ECB-8D69-B46948729227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C826A1-0E54-4645-9868-FD5C8A5C18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039988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4D0773-A954-4ECB-8D69-B46948729227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C826A1-0E54-4645-9868-FD5C8A5C18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029348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56193" y="2119651"/>
            <a:ext cx="6884776" cy="8395866"/>
            <a:chOff x="27856" y="1269419"/>
            <a:chExt cx="6884776" cy="8395866"/>
          </a:xfrm>
        </p:grpSpPr>
        <p:sp>
          <p:nvSpPr>
            <p:cNvPr id="5" name="TextBox 4"/>
            <p:cNvSpPr txBox="1"/>
            <p:nvPr/>
          </p:nvSpPr>
          <p:spPr>
            <a:xfrm>
              <a:off x="27856" y="9403675"/>
              <a:ext cx="654940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2 </a:t>
              </a:r>
              <a:r>
                <a:rPr lang="en-GB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: Sub-group analysis exploring whether removal of biased studies affects outcomes</a:t>
              </a:r>
              <a:endPara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6" name="Group 5"/>
            <p:cNvGrpSpPr/>
            <p:nvPr/>
          </p:nvGrpSpPr>
          <p:grpSpPr>
            <a:xfrm>
              <a:off x="27856" y="1269419"/>
              <a:ext cx="6884776" cy="6188721"/>
              <a:chOff x="27856" y="1269419"/>
              <a:chExt cx="6884776" cy="6188721"/>
            </a:xfrm>
          </p:grpSpPr>
          <p:sp>
            <p:nvSpPr>
              <p:cNvPr id="7" name="TextBox 6"/>
              <p:cNvSpPr txBox="1"/>
              <p:nvPr/>
            </p:nvSpPr>
            <p:spPr>
              <a:xfrm>
                <a:off x="27856" y="1277024"/>
                <a:ext cx="263405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r>
                  <a:rPr lang="en-GB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 Birth </a:t>
                </a:r>
                <a:r>
                  <a:rPr lang="en-GB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eight </a:t>
                </a:r>
                <a:r>
                  <a:rPr lang="en-GB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bias studies removed</a:t>
                </a:r>
                <a:r>
                  <a:rPr lang="en-GB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endPara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3447741" y="4572000"/>
                <a:ext cx="211743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) SGA (bias studies removed)</a:t>
                </a:r>
              </a:p>
            </p:txBody>
          </p:sp>
          <p:sp>
            <p:nvSpPr>
              <p:cNvPr id="9" name="Rectangle 8"/>
              <p:cNvSpPr/>
              <p:nvPr/>
            </p:nvSpPr>
            <p:spPr>
              <a:xfrm>
                <a:off x="3429000" y="1269419"/>
                <a:ext cx="3483632" cy="276999"/>
              </a:xfrm>
              <a:prstGeom prst="rect">
                <a:avLst/>
              </a:prstGeom>
            </p:spPr>
            <p:txBody>
              <a:bodyPr>
                <a:spAutoFit/>
              </a:bodyPr>
              <a:lstStyle/>
              <a:p>
                <a:r>
                  <a:rPr lang="en-GB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) </a:t>
                </a:r>
                <a:r>
                  <a:rPr lang="en-GB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acrosomia </a:t>
                </a:r>
                <a:r>
                  <a:rPr lang="en-GB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bias studies removed</a:t>
                </a:r>
                <a:r>
                  <a:rPr lang="en-GB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</a:p>
            </p:txBody>
          </p:sp>
          <p:sp>
            <p:nvSpPr>
              <p:cNvPr id="10" name="Rectangle 9"/>
              <p:cNvSpPr/>
              <p:nvPr/>
            </p:nvSpPr>
            <p:spPr>
              <a:xfrm>
                <a:off x="77667" y="4571999"/>
                <a:ext cx="2119042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GB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) </a:t>
                </a:r>
                <a:r>
                  <a:rPr lang="en-GB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GA </a:t>
                </a:r>
                <a:r>
                  <a:rPr lang="en-GB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</a:t>
                </a:r>
                <a:r>
                  <a:rPr lang="en-GB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ias </a:t>
                </a:r>
                <a:r>
                  <a:rPr lang="en-GB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tudies removed</a:t>
                </a:r>
                <a:r>
                  <a:rPr lang="en-GB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</a:p>
            </p:txBody>
          </p:sp>
          <p:pic>
            <p:nvPicPr>
              <p:cNvPr id="11" name="Picture 10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77667" y="1751220"/>
                <a:ext cx="3226426" cy="2238068"/>
              </a:xfrm>
              <a:prstGeom prst="rect">
                <a:avLst/>
              </a:prstGeom>
            </p:spPr>
          </p:pic>
          <p:pic>
            <p:nvPicPr>
              <p:cNvPr id="12" name="Picture 11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3447741" y="1751220"/>
                <a:ext cx="3226426" cy="2289436"/>
              </a:xfrm>
              <a:prstGeom prst="rect">
                <a:avLst/>
              </a:prstGeom>
            </p:spPr>
          </p:pic>
          <p:pic>
            <p:nvPicPr>
              <p:cNvPr id="13" name="Picture 12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86885" y="5220072"/>
                <a:ext cx="3217208" cy="2238068"/>
              </a:xfrm>
              <a:prstGeom prst="rect">
                <a:avLst/>
              </a:prstGeom>
            </p:spPr>
          </p:pic>
          <p:pic>
            <p:nvPicPr>
              <p:cNvPr id="14" name="Picture 13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3483632" y="5200104"/>
                <a:ext cx="3190535" cy="2197844"/>
              </a:xfrm>
              <a:prstGeom prst="rect">
                <a:avLst/>
              </a:prstGeom>
            </p:spPr>
          </p:pic>
        </p:grpSp>
      </p:grpSp>
    </p:spTree>
    <p:extLst>
      <p:ext uri="{BB962C8B-B14F-4D97-AF65-F5344CB8AC3E}">
        <p14:creationId xmlns:p14="http://schemas.microsoft.com/office/powerpoint/2010/main" val="23466415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1</TotalTime>
  <Words>46</Words>
  <Application>Microsoft Office PowerPoint</Application>
  <PresentationFormat>Custom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Clinical School Computing Servic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ne Adkins</dc:creator>
  <cp:lastModifiedBy>Windows User</cp:lastModifiedBy>
  <cp:revision>12</cp:revision>
  <cp:lastPrinted>2019-05-01T07:38:58Z</cp:lastPrinted>
  <dcterms:created xsi:type="dcterms:W3CDTF">2019-04-25T11:37:13Z</dcterms:created>
  <dcterms:modified xsi:type="dcterms:W3CDTF">2019-06-08T18:33:27Z</dcterms:modified>
</cp:coreProperties>
</file>